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8"/>
  </p:notesMasterIdLst>
  <p:sldIdLst>
    <p:sldId id="275" r:id="rId2"/>
    <p:sldId id="276" r:id="rId3"/>
    <p:sldId id="274" r:id="rId4"/>
    <p:sldId id="273" r:id="rId5"/>
    <p:sldId id="271" r:id="rId6"/>
    <p:sldId id="283" r:id="rId7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1207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 showGuides="1">
      <p:cViewPr>
        <p:scale>
          <a:sx n="125" d="100"/>
          <a:sy n="125" d="100"/>
        </p:scale>
        <p:origin x="1157" y="-1987"/>
      </p:cViewPr>
      <p:guideLst>
        <p:guide orient="horz" pos="3120"/>
        <p:guide pos="1207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Documents\LPS%20Stress\Hypo\Hypo%203'%20seq\Hypo%203'%20seq%20GO,%20oppousm%20and%20DGE%20function%20list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bar"/>
        <c:grouping val="clustered"/>
        <c:varyColors val="0"/>
        <c:ser>
          <c:idx val="0"/>
          <c:order val="0"/>
          <c:tx>
            <c:strRef>
              <c:f>'Opossum TF analysis'!$N$19</c:f>
              <c:strCache>
                <c:ptCount val="1"/>
                <c:pt idx="0">
                  <c:v>Z-Score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invertIfNegative val="0"/>
          <c:cat>
            <c:strRef>
              <c:f>'Opossum TF analysis'!$M$20:$M$29</c:f>
              <c:strCache>
                <c:ptCount val="10"/>
                <c:pt idx="0">
                  <c:v>Klf4</c:v>
                </c:pt>
                <c:pt idx="1">
                  <c:v>SP1</c:v>
                </c:pt>
                <c:pt idx="2">
                  <c:v>ZNF354C</c:v>
                </c:pt>
                <c:pt idx="3">
                  <c:v>MZF1_5-13</c:v>
                </c:pt>
                <c:pt idx="4">
                  <c:v>HIF1A::ARNT</c:v>
                </c:pt>
                <c:pt idx="5">
                  <c:v>RELA</c:v>
                </c:pt>
                <c:pt idx="6">
                  <c:v>REL</c:v>
                </c:pt>
                <c:pt idx="7">
                  <c:v>NF-kappaB</c:v>
                </c:pt>
                <c:pt idx="8">
                  <c:v>Arnt</c:v>
                </c:pt>
                <c:pt idx="9">
                  <c:v>NFKB1</c:v>
                </c:pt>
              </c:strCache>
            </c:strRef>
          </c:cat>
          <c:val>
            <c:numRef>
              <c:f>'Opossum TF analysis'!$N$20:$N$29</c:f>
              <c:numCache>
                <c:formatCode>General</c:formatCode>
                <c:ptCount val="10"/>
                <c:pt idx="0">
                  <c:v>25.768000000000001</c:v>
                </c:pt>
                <c:pt idx="1">
                  <c:v>26.100999999999999</c:v>
                </c:pt>
                <c:pt idx="2">
                  <c:v>17.783999999999999</c:v>
                </c:pt>
                <c:pt idx="3">
                  <c:v>17.113</c:v>
                </c:pt>
                <c:pt idx="4">
                  <c:v>13.145</c:v>
                </c:pt>
                <c:pt idx="5">
                  <c:v>12.760999999999999</c:v>
                </c:pt>
                <c:pt idx="6">
                  <c:v>12.68</c:v>
                </c:pt>
                <c:pt idx="7">
                  <c:v>10.670999999999999</c:v>
                </c:pt>
                <c:pt idx="8">
                  <c:v>12.64</c:v>
                </c:pt>
                <c:pt idx="9">
                  <c:v>11.101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431-486B-B4EE-4750BF7ABADC}"/>
            </c:ext>
          </c:extLst>
        </c:ser>
        <c:ser>
          <c:idx val="1"/>
          <c:order val="1"/>
          <c:tx>
            <c:strRef>
              <c:f>'Opossum TF analysis'!$O$19</c:f>
              <c:strCache>
                <c:ptCount val="1"/>
                <c:pt idx="0">
                  <c:v>Fischer Score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'Opossum TF analysis'!$M$20:$M$29</c:f>
              <c:strCache>
                <c:ptCount val="10"/>
                <c:pt idx="0">
                  <c:v>Klf4</c:v>
                </c:pt>
                <c:pt idx="1">
                  <c:v>SP1</c:v>
                </c:pt>
                <c:pt idx="2">
                  <c:v>ZNF354C</c:v>
                </c:pt>
                <c:pt idx="3">
                  <c:v>MZF1_5-13</c:v>
                </c:pt>
                <c:pt idx="4">
                  <c:v>HIF1A::ARNT</c:v>
                </c:pt>
                <c:pt idx="5">
                  <c:v>RELA</c:v>
                </c:pt>
                <c:pt idx="6">
                  <c:v>REL</c:v>
                </c:pt>
                <c:pt idx="7">
                  <c:v>NF-kappaB</c:v>
                </c:pt>
                <c:pt idx="8">
                  <c:v>Arnt</c:v>
                </c:pt>
                <c:pt idx="9">
                  <c:v>NFKB1</c:v>
                </c:pt>
              </c:strCache>
            </c:strRef>
          </c:cat>
          <c:val>
            <c:numRef>
              <c:f>'Opossum TF analysis'!$O$20:$O$29</c:f>
              <c:numCache>
                <c:formatCode>General</c:formatCode>
                <c:ptCount val="10"/>
                <c:pt idx="0">
                  <c:v>67.296999999999997</c:v>
                </c:pt>
                <c:pt idx="1">
                  <c:v>66.646000000000001</c:v>
                </c:pt>
                <c:pt idx="2">
                  <c:v>61.647000000000013</c:v>
                </c:pt>
                <c:pt idx="3">
                  <c:v>43.586000000000013</c:v>
                </c:pt>
                <c:pt idx="4">
                  <c:v>29.029</c:v>
                </c:pt>
                <c:pt idx="5">
                  <c:v>23.254999999999999</c:v>
                </c:pt>
                <c:pt idx="6">
                  <c:v>22.998999999999999</c:v>
                </c:pt>
                <c:pt idx="7">
                  <c:v>21.771999999999991</c:v>
                </c:pt>
                <c:pt idx="8">
                  <c:v>16.786000000000001</c:v>
                </c:pt>
                <c:pt idx="9">
                  <c:v>15.62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431-486B-B4EE-4750BF7ABA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82"/>
        <c:axId val="2045310008"/>
        <c:axId val="2045313480"/>
      </c:barChart>
      <c:catAx>
        <c:axId val="2045310008"/>
        <c:scaling>
          <c:orientation val="minMax"/>
        </c:scaling>
        <c:delete val="0"/>
        <c:axPos val="l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5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5313480"/>
        <c:crosses val="autoZero"/>
        <c:auto val="1"/>
        <c:lblAlgn val="ctr"/>
        <c:lblOffset val="100"/>
        <c:noMultiLvlLbl val="0"/>
      </c:catAx>
      <c:valAx>
        <c:axId val="2045313480"/>
        <c:scaling>
          <c:orientation val="minMax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20453100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solidFill>
            <a:sysClr val="windowText" lastClr="000000"/>
          </a:solidFill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16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633006-0990-480D-AA36-A7365DFFD725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1BFBB0-328B-47FE-9A03-F0C9078530E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7163058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680FDB-A1D8-441D-A512-EA8F4B763932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303592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680FDB-A1D8-441D-A512-EA8F4B76393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14902545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680FDB-A1D8-441D-A512-EA8F4B76393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318792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680FDB-A1D8-441D-A512-EA8F4B763932}" type="slidenum">
              <a:rPr lang="en-US" smtClean="0"/>
              <a:t>4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8713169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680FDB-A1D8-441D-A512-EA8F4B76393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410204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6680FDB-A1D8-441D-A512-EA8F4B763932}" type="slidenum">
              <a:rPr lang="en-US" smtClean="0"/>
              <a:t>6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7010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37917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84128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70036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71307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4763298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6462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4805387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74469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99320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41765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584006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92286-74D0-4318-948F-7166F19C29D4}" type="datetimeFigureOut">
              <a:rPr lang="en-GB" smtClean="0"/>
              <a:t>20/05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26FD01F-ABFE-400F-93A4-2D54BBE829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3709045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8.em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9.em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emf"/><Relationship Id="rId13" Type="http://schemas.openxmlformats.org/officeDocument/2006/relationships/oleObject" Target="../embeddings/oleObject12.bin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14.emf"/><Relationship Id="rId2" Type="http://schemas.openxmlformats.org/officeDocument/2006/relationships/notesSlide" Target="../notesSlides/notesSlide4.xml"/><Relationship Id="rId16" Type="http://schemas.openxmlformats.org/officeDocument/2006/relationships/image" Target="../media/image16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1.emf"/><Relationship Id="rId11" Type="http://schemas.openxmlformats.org/officeDocument/2006/relationships/oleObject" Target="../embeddings/oleObject11.bin"/><Relationship Id="rId5" Type="http://schemas.openxmlformats.org/officeDocument/2006/relationships/oleObject" Target="../embeddings/oleObject8.bin"/><Relationship Id="rId15" Type="http://schemas.openxmlformats.org/officeDocument/2006/relationships/oleObject" Target="../embeddings/oleObject13.bin"/><Relationship Id="rId10" Type="http://schemas.openxmlformats.org/officeDocument/2006/relationships/image" Target="../media/image13.emf"/><Relationship Id="rId4" Type="http://schemas.openxmlformats.org/officeDocument/2006/relationships/image" Target="../media/image10.emf"/><Relationship Id="rId9" Type="http://schemas.openxmlformats.org/officeDocument/2006/relationships/oleObject" Target="../embeddings/oleObject10.bin"/><Relationship Id="rId14" Type="http://schemas.openxmlformats.org/officeDocument/2006/relationships/image" Target="../media/image15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3" Type="http://schemas.openxmlformats.org/officeDocument/2006/relationships/oleObject" Target="../embeddings/oleObject14.bin"/><Relationship Id="rId7" Type="http://schemas.openxmlformats.org/officeDocument/2006/relationships/image" Target="../media/image19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8.emf"/><Relationship Id="rId11" Type="http://schemas.openxmlformats.org/officeDocument/2006/relationships/image" Target="../media/image21.emf"/><Relationship Id="rId5" Type="http://schemas.openxmlformats.org/officeDocument/2006/relationships/oleObject" Target="../embeddings/oleObject15.bin"/><Relationship Id="rId10" Type="http://schemas.openxmlformats.org/officeDocument/2006/relationships/oleObject" Target="../embeddings/oleObject17.bin"/><Relationship Id="rId4" Type="http://schemas.openxmlformats.org/officeDocument/2006/relationships/image" Target="../media/image17.emf"/><Relationship Id="rId9" Type="http://schemas.openxmlformats.org/officeDocument/2006/relationships/image" Target="../media/image20.emf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24.emf"/><Relationship Id="rId3" Type="http://schemas.openxmlformats.org/officeDocument/2006/relationships/oleObject" Target="../embeddings/oleObject18.bin"/><Relationship Id="rId7" Type="http://schemas.openxmlformats.org/officeDocument/2006/relationships/oleObject" Target="../embeddings/oleObject20.bin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emf"/><Relationship Id="rId5" Type="http://schemas.openxmlformats.org/officeDocument/2006/relationships/oleObject" Target="../embeddings/oleObject19.bin"/><Relationship Id="rId10" Type="http://schemas.openxmlformats.org/officeDocument/2006/relationships/image" Target="../media/image25.emf"/><Relationship Id="rId4" Type="http://schemas.openxmlformats.org/officeDocument/2006/relationships/image" Target="../media/image22.emf"/><Relationship Id="rId9" Type="http://schemas.openxmlformats.org/officeDocument/2006/relationships/oleObject" Target="../embeddings/oleObject2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extBox 8"/>
          <p:cNvSpPr txBox="1"/>
          <p:nvPr/>
        </p:nvSpPr>
        <p:spPr>
          <a:xfrm>
            <a:off x="232749" y="437900"/>
            <a:ext cx="1731628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dirty="0"/>
              <a:t>Supplementary Figure 1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905962" y="831823"/>
            <a:ext cx="3952020" cy="3569955"/>
            <a:chOff x="4880095" y="2480176"/>
            <a:chExt cx="3448050" cy="2984767"/>
          </a:xfrm>
        </p:grpSpPr>
        <p:pic>
          <p:nvPicPr>
            <p:cNvPr id="11" name="Picture 10" descr="A screenshot of a cell phone&#10;&#10;Description automatically generated">
              <a:extLst>
                <a:ext uri="{FF2B5EF4-FFF2-40B4-BE49-F238E27FC236}">
                  <a16:creationId xmlns:a16="http://schemas.microsoft.com/office/drawing/2014/main" id="{B2C544B9-F81D-4560-8B88-F63B1408295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8674" b="30926"/>
            <a:stretch/>
          </p:blipFill>
          <p:spPr>
            <a:xfrm>
              <a:off x="4899145" y="2535629"/>
              <a:ext cx="3429000" cy="2929314"/>
            </a:xfrm>
            <a:prstGeom prst="rect">
              <a:avLst/>
            </a:prstGeom>
          </p:spPr>
        </p:pic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C1CF57A-DC3B-45F8-B62F-A31B82A29CBD}"/>
                </a:ext>
              </a:extLst>
            </p:cNvPr>
            <p:cNvSpPr txBox="1"/>
            <p:nvPr/>
          </p:nvSpPr>
          <p:spPr>
            <a:xfrm>
              <a:off x="4880095" y="2480176"/>
              <a:ext cx="242235" cy="23749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A</a:t>
              </a:r>
            </a:p>
          </p:txBody>
        </p:sp>
      </p:grpSp>
      <p:graphicFrame>
        <p:nvGraphicFramePr>
          <p:cNvPr id="13" name="Chart 12">
            <a:extLst>
              <a:ext uri="{FF2B5EF4-FFF2-40B4-BE49-F238E27FC236}">
                <a16:creationId xmlns:a16="http://schemas.microsoft.com/office/drawing/2014/main" id="{8A61F338-AD3E-452D-9BF8-C2EA27B70E4D}"/>
              </a:ext>
            </a:extLst>
          </p:cNvPr>
          <p:cNvGraphicFramePr>
            <a:graphicFrameLocks/>
          </p:cNvGraphicFramePr>
          <p:nvPr/>
        </p:nvGraphicFramePr>
        <p:xfrm>
          <a:off x="1148532" y="4953000"/>
          <a:ext cx="3488714" cy="35019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C9BBC322-E69D-4061-9C8D-B18B2AB9B59E}"/>
              </a:ext>
            </a:extLst>
          </p:cNvPr>
          <p:cNvSpPr txBox="1"/>
          <p:nvPr/>
        </p:nvSpPr>
        <p:spPr>
          <a:xfrm>
            <a:off x="906360" y="4979158"/>
            <a:ext cx="42874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46" dirty="0"/>
              <a:t>B</a:t>
            </a:r>
            <a:endParaRPr lang="en-US" sz="1246" dirty="0"/>
          </a:p>
        </p:txBody>
      </p:sp>
    </p:spTree>
    <p:extLst>
      <p:ext uri="{BB962C8B-B14F-4D97-AF65-F5344CB8AC3E}">
        <p14:creationId xmlns:p14="http://schemas.microsoft.com/office/powerpoint/2010/main" val="1214572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053630" y="3861912"/>
            <a:ext cx="4061885" cy="2650041"/>
            <a:chOff x="1687009" y="7685106"/>
            <a:chExt cx="5867167" cy="3827837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7FDA231B-961D-43AD-B225-515377A4C8F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1867507" y="8017278"/>
              <a:ext cx="5686669" cy="3495665"/>
            </a:xfrm>
            <a:prstGeom prst="rect">
              <a:avLst/>
            </a:prstGeom>
          </p:spPr>
        </p:pic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6BFBCF1-D7A5-4FFC-8E4E-5A3DBADCFAC6}"/>
                </a:ext>
              </a:extLst>
            </p:cNvPr>
            <p:cNvSpPr txBox="1"/>
            <p:nvPr/>
          </p:nvSpPr>
          <p:spPr>
            <a:xfrm>
              <a:off x="1687009" y="7685106"/>
              <a:ext cx="391774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B</a:t>
              </a: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1649705" y="1732451"/>
            <a:ext cx="3119654" cy="2244444"/>
            <a:chOff x="2571501" y="4593527"/>
            <a:chExt cx="4506167" cy="3241974"/>
          </a:xfrm>
        </p:grpSpPr>
        <p:pic>
          <p:nvPicPr>
            <p:cNvPr id="8" name="Picture 7">
              <a:extLst>
                <a:ext uri="{FF2B5EF4-FFF2-40B4-BE49-F238E27FC236}">
                  <a16:creationId xmlns:a16="http://schemas.microsoft.com/office/drawing/2014/main" id="{254F5D14-1882-4B59-AEE0-CCC9C7B2355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24071" t="29910" r="14782"/>
            <a:stretch/>
          </p:blipFill>
          <p:spPr>
            <a:xfrm>
              <a:off x="2757610" y="4925699"/>
              <a:ext cx="4320058" cy="2909802"/>
            </a:xfrm>
            <a:prstGeom prst="rect">
              <a:avLst/>
            </a:prstGeom>
          </p:spPr>
        </p:pic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86A6476B-5CC5-448B-94A5-648A97ACB7F7}"/>
                </a:ext>
              </a:extLst>
            </p:cNvPr>
            <p:cNvSpPr txBox="1"/>
            <p:nvPr/>
          </p:nvSpPr>
          <p:spPr>
            <a:xfrm>
              <a:off x="2571501" y="4593527"/>
              <a:ext cx="401036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A</a:t>
              </a:r>
            </a:p>
          </p:txBody>
        </p:sp>
      </p:grpSp>
      <p:sp>
        <p:nvSpPr>
          <p:cNvPr id="14" name="TextBox 13"/>
          <p:cNvSpPr txBox="1"/>
          <p:nvPr/>
        </p:nvSpPr>
        <p:spPr>
          <a:xfrm>
            <a:off x="232749" y="437900"/>
            <a:ext cx="1731628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dirty="0"/>
              <a:t>Supplementary Figure 2</a:t>
            </a:r>
          </a:p>
        </p:txBody>
      </p:sp>
    </p:spTree>
    <p:extLst>
      <p:ext uri="{BB962C8B-B14F-4D97-AF65-F5344CB8AC3E}">
        <p14:creationId xmlns:p14="http://schemas.microsoft.com/office/powerpoint/2010/main" val="218789491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7" name="Group 16"/>
          <p:cNvGrpSpPr/>
          <p:nvPr/>
        </p:nvGrpSpPr>
        <p:grpSpPr>
          <a:xfrm>
            <a:off x="1115285" y="6104826"/>
            <a:ext cx="4506981" cy="2345970"/>
            <a:chOff x="1631287" y="7675098"/>
            <a:chExt cx="6510083" cy="3388623"/>
          </a:xfrm>
        </p:grpSpPr>
        <p:graphicFrame>
          <p:nvGraphicFramePr>
            <p:cNvPr id="6" name="Object 5">
              <a:extLst>
                <a:ext uri="{FF2B5EF4-FFF2-40B4-BE49-F238E27FC236}">
                  <a16:creationId xmlns:a16="http://schemas.microsoft.com/office/drawing/2014/main" id="{E44E04BB-2EA6-4719-BEA1-F0B78E81E708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671921" y="8109190"/>
            <a:ext cx="3054089" cy="29545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3" imgW="3312000" imgH="3204000" progId="Prism5.Document">
                    <p:embed/>
                  </p:oleObj>
                </mc:Choice>
                <mc:Fallback>
                  <p:oleObj name="Prism Project" r:id="rId3" imgW="3312000" imgH="3204000" progId="Prism5.Document">
                    <p:embed/>
                    <p:pic>
                      <p:nvPicPr>
                        <p:cNvPr id="6" name="Object 5">
                          <a:extLst>
                            <a:ext uri="{FF2B5EF4-FFF2-40B4-BE49-F238E27FC236}">
                              <a16:creationId xmlns:a16="http://schemas.microsoft.com/office/drawing/2014/main" id="{E44E04BB-2EA6-4719-BEA1-F0B78E81E70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671921" y="8109190"/>
                          <a:ext cx="3054089" cy="29545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7" name="Object 6">
              <a:extLst>
                <a:ext uri="{FF2B5EF4-FFF2-40B4-BE49-F238E27FC236}">
                  <a16:creationId xmlns:a16="http://schemas.microsoft.com/office/drawing/2014/main" id="{0A0C6853-1EA3-48B9-8ABF-A658DA34D1F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655374" y="8109190"/>
            <a:ext cx="3485996" cy="29545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5" imgW="3780000" imgH="3204000" progId="Prism5.Document">
                    <p:embed/>
                  </p:oleObj>
                </mc:Choice>
                <mc:Fallback>
                  <p:oleObj name="Prism Project" r:id="rId5" imgW="3780000" imgH="3204000" progId="Prism5.Document">
                    <p:embed/>
                    <p:pic>
                      <p:nvPicPr>
                        <p:cNvPr id="7" name="Object 6">
                          <a:extLst>
                            <a:ext uri="{FF2B5EF4-FFF2-40B4-BE49-F238E27FC236}">
                              <a16:creationId xmlns:a16="http://schemas.microsoft.com/office/drawing/2014/main" id="{0A0C6853-1EA3-48B9-8ABF-A658DA34D1F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655374" y="8109190"/>
                          <a:ext cx="3485996" cy="29545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2A1786AE-F2D7-45DE-9B8F-D84932846D3A}"/>
                </a:ext>
              </a:extLst>
            </p:cNvPr>
            <p:cNvSpPr txBox="1"/>
            <p:nvPr/>
          </p:nvSpPr>
          <p:spPr>
            <a:xfrm>
              <a:off x="4842551" y="7676766"/>
              <a:ext cx="373250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F</a:t>
              </a:r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3641C7F3-613D-43E5-BF41-646F326FE944}"/>
                </a:ext>
              </a:extLst>
            </p:cNvPr>
            <p:cNvSpPr txBox="1"/>
            <p:nvPr/>
          </p:nvSpPr>
          <p:spPr>
            <a:xfrm>
              <a:off x="1631287" y="7675098"/>
              <a:ext cx="380198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E</a:t>
              </a:r>
            </a:p>
          </p:txBody>
        </p:sp>
      </p:grpSp>
      <p:grpSp>
        <p:nvGrpSpPr>
          <p:cNvPr id="18" name="Group 17"/>
          <p:cNvGrpSpPr/>
          <p:nvPr/>
        </p:nvGrpSpPr>
        <p:grpSpPr>
          <a:xfrm>
            <a:off x="1092381" y="4038172"/>
            <a:ext cx="4384977" cy="2268154"/>
            <a:chOff x="1598204" y="4947301"/>
            <a:chExt cx="6333856" cy="3276223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72947823-692B-4041-8E24-48270FF6A97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598204" y="5268992"/>
            <a:ext cx="3121437" cy="29545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7" imgW="3384000" imgH="3204000" progId="Prism5.Document">
                    <p:embed/>
                  </p:oleObj>
                </mc:Choice>
                <mc:Fallback>
                  <p:oleObj name="Prism Project" r:id="rId7" imgW="3384000" imgH="3204000" progId="Prism5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72947823-692B-4041-8E24-48270FF6A97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1598204" y="5268992"/>
                          <a:ext cx="3121437" cy="29545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739F327F-B733-427C-B860-66FF1FAE6AB0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778412" y="5268993"/>
            <a:ext cx="3153648" cy="29545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9" imgW="3420000" imgH="3204000" progId="Prism5.Document">
                    <p:embed/>
                  </p:oleObj>
                </mc:Choice>
                <mc:Fallback>
                  <p:oleObj name="Prism Project" r:id="rId9" imgW="3420000" imgH="3204000" progId="Prism5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739F327F-B733-427C-B860-66FF1FAE6AB0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4778412" y="5268993"/>
                          <a:ext cx="3153648" cy="29545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22FBAA2-6019-4F35-8F6B-A85BAE2924F5}"/>
                </a:ext>
              </a:extLst>
            </p:cNvPr>
            <p:cNvSpPr txBox="1"/>
            <p:nvPr/>
          </p:nvSpPr>
          <p:spPr>
            <a:xfrm>
              <a:off x="4804771" y="4947301"/>
              <a:ext cx="407983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D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CD301C65-8443-48FC-AFD0-1143EB4C4CD5}"/>
                </a:ext>
              </a:extLst>
            </p:cNvPr>
            <p:cNvSpPr txBox="1"/>
            <p:nvPr/>
          </p:nvSpPr>
          <p:spPr>
            <a:xfrm>
              <a:off x="1615334" y="4948861"/>
              <a:ext cx="389460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C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1029904" y="2147907"/>
            <a:ext cx="4419422" cy="2077253"/>
            <a:chOff x="1507959" y="2890839"/>
            <a:chExt cx="6383609" cy="3000477"/>
          </a:xfrm>
        </p:grpSpPr>
        <p:graphicFrame>
          <p:nvGraphicFramePr>
            <p:cNvPr id="2" name="Object 1">
              <a:extLst>
                <a:ext uri="{FF2B5EF4-FFF2-40B4-BE49-F238E27FC236}">
                  <a16:creationId xmlns:a16="http://schemas.microsoft.com/office/drawing/2014/main" id="{3EA27B2E-8D0F-4CA1-A590-5128AA16B46C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507959" y="2936785"/>
            <a:ext cx="3220995" cy="29545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11" imgW="3492000" imgH="3204000" progId="Prism5.Document">
                    <p:embed/>
                  </p:oleObj>
                </mc:Choice>
                <mc:Fallback>
                  <p:oleObj name="Prism Project" r:id="rId11" imgW="3492000" imgH="3204000" progId="Prism5.Document">
                    <p:embed/>
                    <p:pic>
                      <p:nvPicPr>
                        <p:cNvPr id="2" name="Object 1">
                          <a:extLst>
                            <a:ext uri="{FF2B5EF4-FFF2-40B4-BE49-F238E27FC236}">
                              <a16:creationId xmlns:a16="http://schemas.microsoft.com/office/drawing/2014/main" id="{3EA27B2E-8D0F-4CA1-A590-5128AA16B46C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2"/>
                        <a:stretch>
                          <a:fillRect/>
                        </a:stretch>
                      </p:blipFill>
                      <p:spPr>
                        <a:xfrm>
                          <a:off x="1507959" y="2936785"/>
                          <a:ext cx="3220995" cy="29545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831EA580-4A76-48B5-861A-D11CA934367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704247" y="2936785"/>
            <a:ext cx="3187321" cy="2954531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13" imgW="3456000" imgH="3204000" progId="Prism5.Document">
                    <p:embed/>
                  </p:oleObj>
                </mc:Choice>
                <mc:Fallback>
                  <p:oleObj name="Prism Project" r:id="rId13" imgW="3456000" imgH="3204000" progId="Prism5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831EA580-4A76-48B5-861A-D11CA934367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4"/>
                        <a:stretch>
                          <a:fillRect/>
                        </a:stretch>
                      </p:blipFill>
                      <p:spPr>
                        <a:xfrm>
                          <a:off x="4704247" y="2936785"/>
                          <a:ext cx="3187321" cy="2954531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AFC2C8FA-11FF-4673-8F47-4FAB5EDD431D}"/>
                </a:ext>
              </a:extLst>
            </p:cNvPr>
            <p:cNvSpPr txBox="1"/>
            <p:nvPr/>
          </p:nvSpPr>
          <p:spPr>
            <a:xfrm>
              <a:off x="4818478" y="2890839"/>
              <a:ext cx="391774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B</a:t>
              </a:r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3F4F094E-8B79-491E-82C4-04C612D34916}"/>
                </a:ext>
              </a:extLst>
            </p:cNvPr>
            <p:cNvSpPr txBox="1"/>
            <p:nvPr/>
          </p:nvSpPr>
          <p:spPr>
            <a:xfrm>
              <a:off x="1598202" y="2891155"/>
              <a:ext cx="401036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A</a:t>
              </a:r>
            </a:p>
          </p:txBody>
        </p:sp>
      </p:grpSp>
      <p:sp>
        <p:nvSpPr>
          <p:cNvPr id="15" name="TextBox 14"/>
          <p:cNvSpPr txBox="1"/>
          <p:nvPr/>
        </p:nvSpPr>
        <p:spPr>
          <a:xfrm>
            <a:off x="232749" y="437900"/>
            <a:ext cx="1731628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dirty="0"/>
              <a:t>Supplementary Figure 3</a:t>
            </a:r>
          </a:p>
        </p:txBody>
      </p:sp>
    </p:spTree>
    <p:extLst>
      <p:ext uri="{BB962C8B-B14F-4D97-AF65-F5344CB8AC3E}">
        <p14:creationId xmlns:p14="http://schemas.microsoft.com/office/powerpoint/2010/main" val="20971306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8" name="Group 17"/>
          <p:cNvGrpSpPr/>
          <p:nvPr/>
        </p:nvGrpSpPr>
        <p:grpSpPr>
          <a:xfrm>
            <a:off x="232749" y="437900"/>
            <a:ext cx="5177829" cy="8291251"/>
            <a:chOff x="336192" y="336188"/>
            <a:chExt cx="7479087" cy="11976251"/>
          </a:xfrm>
        </p:grpSpPr>
        <p:grpSp>
          <p:nvGrpSpPr>
            <p:cNvPr id="8" name="Group 7"/>
            <p:cNvGrpSpPr/>
            <p:nvPr/>
          </p:nvGrpSpPr>
          <p:grpSpPr>
            <a:xfrm>
              <a:off x="1469762" y="1098798"/>
              <a:ext cx="6345517" cy="8305391"/>
              <a:chOff x="1637858" y="2686352"/>
              <a:chExt cx="6345517" cy="8305391"/>
            </a:xfrm>
          </p:grpSpPr>
          <p:graphicFrame>
            <p:nvGraphicFramePr>
              <p:cNvPr id="2" name="Object 1">
                <a:extLst>
                  <a:ext uri="{FF2B5EF4-FFF2-40B4-BE49-F238E27FC236}">
                    <a16:creationId xmlns:a16="http://schemas.microsoft.com/office/drawing/2014/main" id="{D335C15D-B841-4169-85BF-DB99019924C1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1796716" y="2824215"/>
              <a:ext cx="3012242" cy="273569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Project" r:id="rId3" imgW="3528000" imgH="3204000" progId="Prism5.Document">
                      <p:embed/>
                    </p:oleObj>
                  </mc:Choice>
                  <mc:Fallback>
                    <p:oleObj name="Prism Project" r:id="rId3" imgW="3528000" imgH="3204000" progId="Prism5.Document">
                      <p:embed/>
                      <p:pic>
                        <p:nvPicPr>
                          <p:cNvPr id="2" name="Object 1">
                            <a:extLst>
                              <a:ext uri="{FF2B5EF4-FFF2-40B4-BE49-F238E27FC236}">
                                <a16:creationId xmlns:a16="http://schemas.microsoft.com/office/drawing/2014/main" id="{D335C15D-B841-4169-85BF-DB99019924C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4"/>
                          <a:stretch>
                            <a:fillRect/>
                          </a:stretch>
                        </p:blipFill>
                        <p:spPr>
                          <a:xfrm>
                            <a:off x="1796716" y="2824215"/>
                            <a:ext cx="3012242" cy="273569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3" name="Object 2">
                <a:extLst>
                  <a:ext uri="{FF2B5EF4-FFF2-40B4-BE49-F238E27FC236}">
                    <a16:creationId xmlns:a16="http://schemas.microsoft.com/office/drawing/2014/main" id="{A1DE708C-B298-47AA-BD0E-D398BE771D7B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4792916" y="2832238"/>
              <a:ext cx="2951238" cy="273569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Project" r:id="rId5" imgW="3456000" imgH="3204000" progId="Prism5.Document">
                      <p:embed/>
                    </p:oleObj>
                  </mc:Choice>
                  <mc:Fallback>
                    <p:oleObj name="Prism Project" r:id="rId5" imgW="3456000" imgH="3204000" progId="Prism5.Document">
                      <p:embed/>
                      <p:pic>
                        <p:nvPicPr>
                          <p:cNvPr id="3" name="Object 2">
                            <a:extLst>
                              <a:ext uri="{FF2B5EF4-FFF2-40B4-BE49-F238E27FC236}">
                                <a16:creationId xmlns:a16="http://schemas.microsoft.com/office/drawing/2014/main" id="{A1DE708C-B298-47AA-BD0E-D398BE771D7B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6"/>
                          <a:stretch>
                            <a:fillRect/>
                          </a:stretch>
                        </p:blipFill>
                        <p:spPr>
                          <a:xfrm>
                            <a:off x="4792916" y="2832238"/>
                            <a:ext cx="2951238" cy="273569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4" name="Object 3">
                <a:extLst>
                  <a:ext uri="{FF2B5EF4-FFF2-40B4-BE49-F238E27FC236}">
                    <a16:creationId xmlns:a16="http://schemas.microsoft.com/office/drawing/2014/main" id="{2AEA7119-E648-4B62-8C89-D70A1B3D5DED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1929522" y="5569208"/>
              <a:ext cx="2890233" cy="273569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Project" r:id="rId7" imgW="3384000" imgH="3204000" progId="Prism5.Document">
                      <p:embed/>
                    </p:oleObj>
                  </mc:Choice>
                  <mc:Fallback>
                    <p:oleObj name="Prism Project" r:id="rId7" imgW="3384000" imgH="3204000" progId="Prism5.Document">
                      <p:embed/>
                      <p:pic>
                        <p:nvPicPr>
                          <p:cNvPr id="4" name="Object 3">
                            <a:extLst>
                              <a:ext uri="{FF2B5EF4-FFF2-40B4-BE49-F238E27FC236}">
                                <a16:creationId xmlns:a16="http://schemas.microsoft.com/office/drawing/2014/main" id="{2AEA7119-E648-4B62-8C89-D70A1B3D5DED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8"/>
                          <a:stretch>
                            <a:fillRect/>
                          </a:stretch>
                        </p:blipFill>
                        <p:spPr>
                          <a:xfrm>
                            <a:off x="1929522" y="5569208"/>
                            <a:ext cx="2890233" cy="273569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5" name="Object 4">
                <a:extLst>
                  <a:ext uri="{FF2B5EF4-FFF2-40B4-BE49-F238E27FC236}">
                    <a16:creationId xmlns:a16="http://schemas.microsoft.com/office/drawing/2014/main" id="{00200C95-3683-4DC7-9A13-7BED28EB1B25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4755585" y="5570345"/>
              <a:ext cx="3227790" cy="2735691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Project" r:id="rId9" imgW="3780000" imgH="3204000" progId="Prism5.Document">
                      <p:embed/>
                    </p:oleObj>
                  </mc:Choice>
                  <mc:Fallback>
                    <p:oleObj name="Prism Project" r:id="rId9" imgW="3780000" imgH="3204000" progId="Prism5.Document">
                      <p:embed/>
                      <p:pic>
                        <p:nvPicPr>
                          <p:cNvPr id="5" name="Object 4">
                            <a:extLst>
                              <a:ext uri="{FF2B5EF4-FFF2-40B4-BE49-F238E27FC236}">
                                <a16:creationId xmlns:a16="http://schemas.microsoft.com/office/drawing/2014/main" id="{00200C95-3683-4DC7-9A13-7BED28EB1B25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0"/>
                          <a:stretch>
                            <a:fillRect/>
                          </a:stretch>
                        </p:blipFill>
                        <p:spPr>
                          <a:xfrm>
                            <a:off x="4755585" y="5570345"/>
                            <a:ext cx="3227790" cy="2735691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6" name="Object 5">
                <a:extLst>
                  <a:ext uri="{FF2B5EF4-FFF2-40B4-BE49-F238E27FC236}">
                    <a16:creationId xmlns:a16="http://schemas.microsoft.com/office/drawing/2014/main" id="{E0C9D507-5274-49D4-872F-A765D580E5B1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1929521" y="8256053"/>
              <a:ext cx="2890233" cy="273569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Project" r:id="rId11" imgW="3384000" imgH="3204000" progId="Prism5.Document">
                      <p:embed/>
                    </p:oleObj>
                  </mc:Choice>
                  <mc:Fallback>
                    <p:oleObj name="Prism Project" r:id="rId11" imgW="3384000" imgH="3204000" progId="Prism5.Document">
                      <p:embed/>
                      <p:pic>
                        <p:nvPicPr>
                          <p:cNvPr id="6" name="Object 5">
                            <a:extLst>
                              <a:ext uri="{FF2B5EF4-FFF2-40B4-BE49-F238E27FC236}">
                                <a16:creationId xmlns:a16="http://schemas.microsoft.com/office/drawing/2014/main" id="{E0C9D507-5274-49D4-872F-A765D580E5B1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2"/>
                          <a:stretch>
                            <a:fillRect/>
                          </a:stretch>
                        </p:blipFill>
                        <p:spPr>
                          <a:xfrm>
                            <a:off x="1929521" y="8256053"/>
                            <a:ext cx="2890233" cy="273569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7" name="Object 6">
                <a:extLst>
                  <a:ext uri="{FF2B5EF4-FFF2-40B4-BE49-F238E27FC236}">
                    <a16:creationId xmlns:a16="http://schemas.microsoft.com/office/drawing/2014/main" id="{B371492F-16FC-49E1-9E5F-57F01C2FB47F}"/>
                  </a:ext>
                </a:extLst>
              </p:cNvPr>
              <p:cNvGraphicFramePr>
                <a:graphicFrameLocks noChangeAspect="1"/>
              </p:cNvGraphicFramePr>
              <p:nvPr/>
            </p:nvGraphicFramePr>
            <p:xfrm>
              <a:off x="4776874" y="8378257"/>
              <a:ext cx="3063408" cy="2596370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name="Prism Project" r:id="rId13" imgW="3780000" imgH="3204000" progId="Prism5.Document">
                      <p:embed/>
                    </p:oleObj>
                  </mc:Choice>
                  <mc:Fallback>
                    <p:oleObj name="Prism Project" r:id="rId13" imgW="3780000" imgH="3204000" progId="Prism5.Document">
                      <p:embed/>
                      <p:pic>
                        <p:nvPicPr>
                          <p:cNvPr id="7" name="Object 6">
                            <a:extLst>
                              <a:ext uri="{FF2B5EF4-FFF2-40B4-BE49-F238E27FC236}">
                                <a16:creationId xmlns:a16="http://schemas.microsoft.com/office/drawing/2014/main" id="{B371492F-16FC-49E1-9E5F-57F01C2FB47F}"/>
                              </a:ext>
                            </a:extLst>
                          </p:cNvPr>
                          <p:cNvPicPr/>
                          <p:nvPr/>
                        </p:nvPicPr>
                        <p:blipFill>
                          <a:blip r:embed="rId14"/>
                          <a:stretch>
                            <a:fillRect/>
                          </a:stretch>
                        </p:blipFill>
                        <p:spPr>
                          <a:xfrm>
                            <a:off x="4776874" y="8378257"/>
                            <a:ext cx="3063408" cy="2596370"/>
                          </a:xfrm>
                          <a:prstGeom prst="rect">
                            <a:avLst/>
                          </a:prstGeom>
                        </p:spPr>
                      </p:pic>
                    </p:oleObj>
                  </mc:Fallback>
                </mc:AlternateContent>
              </a:graphicData>
            </a:graphic>
          </p:graphicFrame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076700C-5D25-43DA-9F2E-D5DEFBB2CFC4}"/>
                  </a:ext>
                </a:extLst>
              </p:cNvPr>
              <p:cNvSpPr txBox="1"/>
              <p:nvPr/>
            </p:nvSpPr>
            <p:spPr>
              <a:xfrm>
                <a:off x="4850308" y="7928879"/>
                <a:ext cx="373250" cy="4102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46" dirty="0"/>
                  <a:t>F</a:t>
                </a:r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73945AA3-5C14-4EF9-A287-CF82AB384A9B}"/>
                  </a:ext>
                </a:extLst>
              </p:cNvPr>
              <p:cNvSpPr txBox="1"/>
              <p:nvPr/>
            </p:nvSpPr>
            <p:spPr>
              <a:xfrm>
                <a:off x="1670943" y="7905947"/>
                <a:ext cx="380198" cy="4102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46" dirty="0"/>
                  <a:t>E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127A07DB-7E5D-4A1F-80D8-41718EC1FA35}"/>
                  </a:ext>
                </a:extLst>
              </p:cNvPr>
              <p:cNvSpPr txBox="1"/>
              <p:nvPr/>
            </p:nvSpPr>
            <p:spPr>
              <a:xfrm>
                <a:off x="4812528" y="5233872"/>
                <a:ext cx="407983" cy="4102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46" dirty="0"/>
                  <a:t>D</a:t>
                </a:r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75558483-B103-48BA-9ECE-C8F3A5C86C28}"/>
                  </a:ext>
                </a:extLst>
              </p:cNvPr>
              <p:cNvSpPr txBox="1"/>
              <p:nvPr/>
            </p:nvSpPr>
            <p:spPr>
              <a:xfrm>
                <a:off x="1654989" y="5271466"/>
                <a:ext cx="389460" cy="4102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46" dirty="0"/>
                  <a:t>C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C88A34B3-4C97-4D40-967C-653E6DA7CD82}"/>
                  </a:ext>
                </a:extLst>
              </p:cNvPr>
              <p:cNvSpPr txBox="1"/>
              <p:nvPr/>
            </p:nvSpPr>
            <p:spPr>
              <a:xfrm>
                <a:off x="4815601" y="2686352"/>
                <a:ext cx="391774" cy="4102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46" dirty="0"/>
                  <a:t>B</a:t>
                </a:r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7B858F8-3C42-4515-840E-AC370C74189B}"/>
                  </a:ext>
                </a:extLst>
              </p:cNvPr>
              <p:cNvSpPr txBox="1"/>
              <p:nvPr/>
            </p:nvSpPr>
            <p:spPr>
              <a:xfrm>
                <a:off x="1637858" y="2686668"/>
                <a:ext cx="401036" cy="4102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46" dirty="0"/>
                  <a:t>A</a:t>
                </a:r>
              </a:p>
            </p:txBody>
          </p:sp>
        </p:grpSp>
        <p:sp>
          <p:nvSpPr>
            <p:cNvPr id="15" name="TextBox 14"/>
            <p:cNvSpPr txBox="1"/>
            <p:nvPr/>
          </p:nvSpPr>
          <p:spPr>
            <a:xfrm>
              <a:off x="336192" y="336188"/>
              <a:ext cx="2501241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Supplementary Figure 4</a:t>
              </a:r>
            </a:p>
          </p:txBody>
        </p:sp>
        <p:graphicFrame>
          <p:nvGraphicFramePr>
            <p:cNvPr id="16" name="Object 15">
              <a:extLst>
                <a:ext uri="{FF2B5EF4-FFF2-40B4-BE49-F238E27FC236}">
                  <a16:creationId xmlns:a16="http://schemas.microsoft.com/office/drawing/2014/main" id="{9FEAE10B-C834-4455-83B8-DE76FD7AA92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3383126" y="9359689"/>
            <a:ext cx="3455987" cy="29527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15" imgW="3456000" imgH="2952000" progId="Prism5.Document">
                    <p:embed/>
                  </p:oleObj>
                </mc:Choice>
                <mc:Fallback>
                  <p:oleObj name="Prism Project" r:id="rId15" imgW="3456000" imgH="2952000" progId="Prism5.Document">
                    <p:embed/>
                    <p:pic>
                      <p:nvPicPr>
                        <p:cNvPr id="16" name="Object 15">
                          <a:extLst>
                            <a:ext uri="{FF2B5EF4-FFF2-40B4-BE49-F238E27FC236}">
                              <a16:creationId xmlns:a16="http://schemas.microsoft.com/office/drawing/2014/main" id="{9FEAE10B-C834-4455-83B8-DE76FD7AA92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6"/>
                        <a:stretch>
                          <a:fillRect/>
                        </a:stretch>
                      </p:blipFill>
                      <p:spPr>
                        <a:xfrm>
                          <a:off x="3383126" y="9359689"/>
                          <a:ext cx="3455987" cy="29527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7" name="TextBox 16"/>
            <p:cNvSpPr txBox="1"/>
            <p:nvPr/>
          </p:nvSpPr>
          <p:spPr>
            <a:xfrm>
              <a:off x="3251200" y="9377680"/>
              <a:ext cx="412614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G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95167126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Group 18"/>
          <p:cNvGrpSpPr/>
          <p:nvPr/>
        </p:nvGrpSpPr>
        <p:grpSpPr>
          <a:xfrm>
            <a:off x="404446" y="804595"/>
            <a:ext cx="5205046" cy="2917482"/>
            <a:chOff x="584200" y="865860"/>
            <a:chExt cx="7518400" cy="4214140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A87967A3-C43E-4DF3-A3FC-10012195CABA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1043859" y="1241632"/>
            <a:ext cx="3665890" cy="38383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3" imgW="3600000" imgH="2988000" progId="Prism5.Document">
                    <p:embed/>
                  </p:oleObj>
                </mc:Choice>
                <mc:Fallback>
                  <p:oleObj name="Prism Project" r:id="rId3" imgW="3600000" imgH="2988000" progId="Prism5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A87967A3-C43E-4DF3-A3FC-10012195CABA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1043859" y="1241632"/>
                          <a:ext cx="3665890" cy="383836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9DE76DA4-2049-4A57-A05F-0EA3841CAE4B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4436705" y="1241630"/>
            <a:ext cx="3665895" cy="3838368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5" imgW="3600000" imgH="2988000" progId="Prism5.Document">
                    <p:embed/>
                  </p:oleObj>
                </mc:Choice>
                <mc:Fallback>
                  <p:oleObj name="Prism Project" r:id="rId5" imgW="3600000" imgH="2988000" progId="Prism5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9DE76DA4-2049-4A57-A05F-0EA3841CAE4B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4436705" y="1241630"/>
                          <a:ext cx="3665895" cy="3838368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C1EB0011-0AFE-455A-BB5C-E58B561E6266}"/>
                </a:ext>
              </a:extLst>
            </p:cNvPr>
            <p:cNvSpPr txBox="1"/>
            <p:nvPr/>
          </p:nvSpPr>
          <p:spPr>
            <a:xfrm>
              <a:off x="4778542" y="875896"/>
              <a:ext cx="391774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B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ACE2298-C044-479C-8E24-7F3623D4F838}"/>
                </a:ext>
              </a:extLst>
            </p:cNvPr>
            <p:cNvSpPr txBox="1"/>
            <p:nvPr/>
          </p:nvSpPr>
          <p:spPr>
            <a:xfrm>
              <a:off x="584200" y="865860"/>
              <a:ext cx="401036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A</a:t>
              </a:r>
            </a:p>
          </p:txBody>
        </p: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5AF02A6B-C157-403C-9F1F-45BCFBD374C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984739" y="6756279"/>
            <a:ext cx="4686362" cy="2803891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232749" y="437900"/>
            <a:ext cx="1731628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dirty="0"/>
              <a:t>Supplementary Figure 5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9446E071-0B62-4C7A-AE0F-AF231FA7760A}"/>
              </a:ext>
            </a:extLst>
          </p:cNvPr>
          <p:cNvSpPr txBox="1"/>
          <p:nvPr/>
        </p:nvSpPr>
        <p:spPr>
          <a:xfrm flipH="1">
            <a:off x="430534" y="7168662"/>
            <a:ext cx="125140" cy="28405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46" dirty="0"/>
              <a:t>E</a:t>
            </a:r>
          </a:p>
        </p:txBody>
      </p:sp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C01691F5-9B23-4D8E-B7EC-1011B6C8EF2E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78600" y="4003431"/>
          <a:ext cx="3006439" cy="24980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8" imgW="3312000" imgH="2880000" progId="Prism5.Document">
                  <p:embed/>
                </p:oleObj>
              </mc:Choice>
              <mc:Fallback>
                <p:oleObj name="Prism Project" r:id="rId8" imgW="3312000" imgH="2880000" progId="Prism5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C01691F5-9B23-4D8E-B7EC-1011B6C8EF2E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78600" y="4003431"/>
                        <a:ext cx="3006439" cy="24980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2A782F2A-A62E-4723-8D4A-E910763732A3}"/>
              </a:ext>
            </a:extLst>
          </p:cNvPr>
          <p:cNvGraphicFramePr>
            <a:graphicFrameLocks noChangeAspect="1"/>
          </p:cNvGraphicFramePr>
          <p:nvPr/>
        </p:nvGraphicFramePr>
        <p:xfrm>
          <a:off x="3260596" y="3893474"/>
          <a:ext cx="3017649" cy="269140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Project" r:id="rId10" imgW="3528000" imgH="3204000" progId="Prism5.Document">
                  <p:embed/>
                </p:oleObj>
              </mc:Choice>
              <mc:Fallback>
                <p:oleObj name="Prism Project" r:id="rId10" imgW="3528000" imgH="3204000" progId="Prism5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2A782F2A-A62E-4723-8D4A-E910763732A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260596" y="3893474"/>
                        <a:ext cx="3017649" cy="269140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DDE28729-B40C-48E4-A97A-3357F5F46588}"/>
              </a:ext>
            </a:extLst>
          </p:cNvPr>
          <p:cNvSpPr txBox="1"/>
          <p:nvPr/>
        </p:nvSpPr>
        <p:spPr>
          <a:xfrm>
            <a:off x="473106" y="3993331"/>
            <a:ext cx="269626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6" dirty="0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6BE3658-EBE2-4CF1-A8CD-7D1B03E95951}"/>
              </a:ext>
            </a:extLst>
          </p:cNvPr>
          <p:cNvSpPr txBox="1"/>
          <p:nvPr/>
        </p:nvSpPr>
        <p:spPr>
          <a:xfrm>
            <a:off x="3327919" y="3993331"/>
            <a:ext cx="282450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46" dirty="0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726404525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oup 6"/>
          <p:cNvGrpSpPr/>
          <p:nvPr/>
        </p:nvGrpSpPr>
        <p:grpSpPr>
          <a:xfrm>
            <a:off x="1617687" y="7043342"/>
            <a:ext cx="3210740" cy="2215763"/>
            <a:chOff x="2239800" y="7091141"/>
            <a:chExt cx="4637735" cy="3200547"/>
          </a:xfrm>
        </p:grpSpPr>
        <p:graphicFrame>
          <p:nvGraphicFramePr>
            <p:cNvPr id="3" name="Object 2">
              <a:extLst>
                <a:ext uri="{FF2B5EF4-FFF2-40B4-BE49-F238E27FC236}">
                  <a16:creationId xmlns:a16="http://schemas.microsoft.com/office/drawing/2014/main" id="{33FFA430-8F3E-49E4-8DCB-0B514493B7F5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239800" y="7484565"/>
            <a:ext cx="4637735" cy="2807123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3" imgW="5292000" imgH="3204000" progId="Prism5.Document">
                    <p:embed/>
                  </p:oleObj>
                </mc:Choice>
                <mc:Fallback>
                  <p:oleObj name="Prism Project" r:id="rId3" imgW="5292000" imgH="3204000" progId="Prism5.Document">
                    <p:embed/>
                    <p:pic>
                      <p:nvPicPr>
                        <p:cNvPr id="3" name="Object 2">
                          <a:extLst>
                            <a:ext uri="{FF2B5EF4-FFF2-40B4-BE49-F238E27FC236}">
                              <a16:creationId xmlns:a16="http://schemas.microsoft.com/office/drawing/2014/main" id="{33FFA430-8F3E-49E4-8DCB-0B514493B7F5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4"/>
                        <a:stretch>
                          <a:fillRect/>
                        </a:stretch>
                      </p:blipFill>
                      <p:spPr>
                        <a:xfrm>
                          <a:off x="2239800" y="7484565"/>
                          <a:ext cx="4637735" cy="2807123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0EAE18B6-5EE2-4069-99B8-68CFD3D2BAF6}"/>
                </a:ext>
              </a:extLst>
            </p:cNvPr>
            <p:cNvSpPr txBox="1"/>
            <p:nvPr/>
          </p:nvSpPr>
          <p:spPr>
            <a:xfrm>
              <a:off x="2451605" y="7091141"/>
              <a:ext cx="407983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D</a:t>
              </a:r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1615190" y="4978087"/>
            <a:ext cx="3231926" cy="2085925"/>
            <a:chOff x="2306636" y="5680871"/>
            <a:chExt cx="4668338" cy="3013003"/>
          </a:xfrm>
        </p:grpSpPr>
        <p:graphicFrame>
          <p:nvGraphicFramePr>
            <p:cNvPr id="4" name="Object 3">
              <a:extLst>
                <a:ext uri="{FF2B5EF4-FFF2-40B4-BE49-F238E27FC236}">
                  <a16:creationId xmlns:a16="http://schemas.microsoft.com/office/drawing/2014/main" id="{3793B56E-87E2-42A6-BE34-10BE8EA5C6C2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306636" y="6106535"/>
            <a:ext cx="4668338" cy="2587339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5" imgW="5328000" imgH="2952000" progId="Prism5.Document">
                    <p:embed/>
                  </p:oleObj>
                </mc:Choice>
                <mc:Fallback>
                  <p:oleObj name="Prism Project" r:id="rId5" imgW="5328000" imgH="2952000" progId="Prism5.Document">
                    <p:embed/>
                    <p:pic>
                      <p:nvPicPr>
                        <p:cNvPr id="4" name="Object 3">
                          <a:extLst>
                            <a:ext uri="{FF2B5EF4-FFF2-40B4-BE49-F238E27FC236}">
                              <a16:creationId xmlns:a16="http://schemas.microsoft.com/office/drawing/2014/main" id="{3793B56E-87E2-42A6-BE34-10BE8EA5C6C2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6"/>
                        <a:stretch>
                          <a:fillRect/>
                        </a:stretch>
                      </p:blipFill>
                      <p:spPr>
                        <a:xfrm>
                          <a:off x="2306636" y="6106535"/>
                          <a:ext cx="4668338" cy="2587339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292EEFB-F8A1-4269-A9CA-48BAA8461B2B}"/>
                </a:ext>
              </a:extLst>
            </p:cNvPr>
            <p:cNvSpPr txBox="1"/>
            <p:nvPr/>
          </p:nvSpPr>
          <p:spPr>
            <a:xfrm>
              <a:off x="2449622" y="5680871"/>
              <a:ext cx="389460" cy="4102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C</a:t>
              </a:r>
            </a:p>
          </p:txBody>
        </p:sp>
      </p:grpSp>
      <p:grpSp>
        <p:nvGrpSpPr>
          <p:cNvPr id="2" name="Group 1"/>
          <p:cNvGrpSpPr/>
          <p:nvPr/>
        </p:nvGrpSpPr>
        <p:grpSpPr>
          <a:xfrm>
            <a:off x="1532343" y="3003730"/>
            <a:ext cx="3057618" cy="2115821"/>
            <a:chOff x="2239800" y="1984183"/>
            <a:chExt cx="4416559" cy="3056193"/>
          </a:xfrm>
        </p:grpSpPr>
        <p:graphicFrame>
          <p:nvGraphicFramePr>
            <p:cNvPr id="5" name="Object 4">
              <a:extLst>
                <a:ext uri="{FF2B5EF4-FFF2-40B4-BE49-F238E27FC236}">
                  <a16:creationId xmlns:a16="http://schemas.microsoft.com/office/drawing/2014/main" id="{4F167C0E-1D09-41BA-B089-285C898BC178}"/>
                </a:ext>
              </a:extLst>
            </p:cNvPr>
            <p:cNvGraphicFramePr>
              <a:graphicFrameLocks noChangeAspect="1"/>
            </p:cNvGraphicFramePr>
            <p:nvPr/>
          </p:nvGraphicFramePr>
          <p:xfrm>
            <a:off x="2239800" y="2284420"/>
            <a:ext cx="4416559" cy="2755956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7" imgW="4788000" imgH="2988000" progId="Prism5.Document">
                    <p:embed/>
                  </p:oleObj>
                </mc:Choice>
                <mc:Fallback>
                  <p:oleObj name="Prism Project" r:id="rId7" imgW="4788000" imgH="2988000" progId="Prism5.Document">
                    <p:embed/>
                    <p:pic>
                      <p:nvPicPr>
                        <p:cNvPr id="5" name="Object 4">
                          <a:extLst>
                            <a:ext uri="{FF2B5EF4-FFF2-40B4-BE49-F238E27FC236}">
                              <a16:creationId xmlns:a16="http://schemas.microsoft.com/office/drawing/2014/main" id="{4F167C0E-1D09-41BA-B089-285C898BC178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8"/>
                        <a:stretch>
                          <a:fillRect/>
                        </a:stretch>
                      </p:blipFill>
                      <p:spPr>
                        <a:xfrm>
                          <a:off x="2239800" y="2284420"/>
                          <a:ext cx="4416559" cy="2755956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97C9D06B-F40E-48BE-85A1-73DAE4F383E6}"/>
                </a:ext>
              </a:extLst>
            </p:cNvPr>
            <p:cNvSpPr txBox="1"/>
            <p:nvPr/>
          </p:nvSpPr>
          <p:spPr>
            <a:xfrm>
              <a:off x="2445203" y="1984183"/>
              <a:ext cx="391774" cy="4102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46" dirty="0"/>
                <a:t>B</a:t>
              </a:r>
            </a:p>
          </p:txBody>
        </p:sp>
      </p:grpSp>
      <p:sp>
        <p:nvSpPr>
          <p:cNvPr id="8" name="TextBox 7"/>
          <p:cNvSpPr txBox="1"/>
          <p:nvPr/>
        </p:nvSpPr>
        <p:spPr>
          <a:xfrm>
            <a:off x="232749" y="437900"/>
            <a:ext cx="1731628" cy="28405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46" dirty="0"/>
              <a:t>Supplementary Figure 6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CE4F071D-3676-4C24-A4A3-3C21B81D0BEA}"/>
              </a:ext>
            </a:extLst>
          </p:cNvPr>
          <p:cNvSpPr txBox="1"/>
          <p:nvPr/>
        </p:nvSpPr>
        <p:spPr>
          <a:xfrm>
            <a:off x="1660564" y="1005057"/>
            <a:ext cx="431800" cy="28469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50" dirty="0"/>
              <a:t>A</a:t>
            </a:r>
          </a:p>
        </p:txBody>
      </p:sp>
      <p:grpSp>
        <p:nvGrpSpPr>
          <p:cNvPr id="14" name="Group 13">
            <a:extLst>
              <a:ext uri="{FF2B5EF4-FFF2-40B4-BE49-F238E27FC236}">
                <a16:creationId xmlns:a16="http://schemas.microsoft.com/office/drawing/2014/main" id="{61CD6FCB-8BA0-4F69-8F7A-6549836E65D2}"/>
              </a:ext>
            </a:extLst>
          </p:cNvPr>
          <p:cNvGrpSpPr/>
          <p:nvPr/>
        </p:nvGrpSpPr>
        <p:grpSpPr>
          <a:xfrm>
            <a:off x="-357167" y="1173942"/>
            <a:ext cx="4947128" cy="1897509"/>
            <a:chOff x="2229252" y="3138972"/>
            <a:chExt cx="7733224" cy="2952750"/>
          </a:xfrm>
        </p:grpSpPr>
        <p:graphicFrame>
          <p:nvGraphicFramePr>
            <p:cNvPr id="15" name="Object 14">
              <a:extLst>
                <a:ext uri="{FF2B5EF4-FFF2-40B4-BE49-F238E27FC236}">
                  <a16:creationId xmlns:a16="http://schemas.microsoft.com/office/drawing/2014/main" id="{6B636317-52CF-4B65-935A-AEE7BEB8F761}"/>
                </a:ext>
              </a:extLst>
            </p:cNvPr>
            <p:cNvGraphicFramePr>
              <a:graphicFrameLocks noChangeAspect="1"/>
            </p:cNvGraphicFramePr>
            <p:nvPr>
              <p:extLst>
                <p:ext uri="{D42A27DB-BD31-4B8C-83A1-F6EECF244321}">
                  <p14:modId xmlns:p14="http://schemas.microsoft.com/office/powerpoint/2010/main" val="4250651128"/>
                </p:ext>
              </p:extLst>
            </p:nvPr>
          </p:nvGraphicFramePr>
          <p:xfrm>
            <a:off x="5282527" y="3138972"/>
            <a:ext cx="4679949" cy="2952750"/>
          </p:xfrm>
          <a:graphic>
            <a:graphicData uri="http://schemas.openxmlformats.org/presentationml/2006/ole">
              <mc:AlternateContent xmlns:mc="http://schemas.openxmlformats.org/markup-compatibility/2006">
                <mc:Choice xmlns:v="urn:schemas-microsoft-com:vml" Requires="v">
                  <p:oleObj name="Prism Project" r:id="rId9" imgW="4680000" imgH="2952000" progId="Prism5.Document">
                    <p:embed/>
                  </p:oleObj>
                </mc:Choice>
                <mc:Fallback>
                  <p:oleObj name="Prism Project" r:id="rId9" imgW="4680000" imgH="2952000" progId="Prism5.Document">
                    <p:embed/>
                    <p:pic>
                      <p:nvPicPr>
                        <p:cNvPr id="15" name="Object 14">
                          <a:extLst>
                            <a:ext uri="{FF2B5EF4-FFF2-40B4-BE49-F238E27FC236}">
                              <a16:creationId xmlns:a16="http://schemas.microsoft.com/office/drawing/2014/main" id="{DA9E6E05-1CB3-4A91-905D-2FC5E514B203}"/>
                            </a:ext>
                          </a:extLst>
                        </p:cNvPr>
                        <p:cNvPicPr/>
                        <p:nvPr/>
                      </p:nvPicPr>
                      <p:blipFill>
                        <a:blip r:embed="rId10"/>
                        <a:stretch>
                          <a:fillRect/>
                        </a:stretch>
                      </p:blipFill>
                      <p:spPr>
                        <a:xfrm>
                          <a:off x="5282527" y="3138972"/>
                          <a:ext cx="4679949" cy="2952750"/>
                        </a:xfrm>
                        <a:prstGeom prst="rect">
                          <a:avLst/>
                        </a:prstGeom>
                      </p:spPr>
                    </p:pic>
                  </p:oleObj>
                </mc:Fallback>
              </mc:AlternateContent>
            </a:graphicData>
          </a:graphic>
        </p:graphicFrame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C3BA4C66-5566-4E56-8FAB-AD3C1A12D936}"/>
                </a:ext>
              </a:extLst>
            </p:cNvPr>
            <p:cNvSpPr txBox="1"/>
            <p:nvPr/>
          </p:nvSpPr>
          <p:spPr>
            <a:xfrm>
              <a:off x="2229252" y="3402012"/>
              <a:ext cx="18473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endParaRPr lang="en-US" dirty="0"/>
            </a:p>
          </p:txBody>
        </p:sp>
      </p:grpSp>
    </p:spTree>
    <p:extLst>
      <p:ext uri="{BB962C8B-B14F-4D97-AF65-F5344CB8AC3E}">
        <p14:creationId xmlns:p14="http://schemas.microsoft.com/office/powerpoint/2010/main" val="64215629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</Words>
  <Application>Microsoft Office PowerPoint</Application>
  <PresentationFormat>A4 Paper (210x297 mm)</PresentationFormat>
  <Paragraphs>38</Paragraphs>
  <Slides>6</Slides>
  <Notes>6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rism Project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amon Fitzgerald</dc:creator>
  <cp:lastModifiedBy>FITZGERALD Eamon</cp:lastModifiedBy>
  <cp:revision>6</cp:revision>
  <dcterms:created xsi:type="dcterms:W3CDTF">2020-09-27T03:46:42Z</dcterms:created>
  <dcterms:modified xsi:type="dcterms:W3CDTF">2021-05-20T13:10:37Z</dcterms:modified>
</cp:coreProperties>
</file>